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800" autoAdjust="0"/>
    <p:restoredTop sz="94660"/>
  </p:normalViewPr>
  <p:slideViewPr>
    <p:cSldViewPr snapToGrid="0">
      <p:cViewPr>
        <p:scale>
          <a:sx n="75" d="100"/>
          <a:sy n="75" d="100"/>
        </p:scale>
        <p:origin x="40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hang hui" userId="7090c9456b8cb81b" providerId="LiveId" clId="{62F64228-9980-41C1-88AD-9232BC37B018}"/>
    <pc:docChg chg="undo custSel modSld">
      <pc:chgData name="zhang hui" userId="7090c9456b8cb81b" providerId="LiveId" clId="{62F64228-9980-41C1-88AD-9232BC37B018}" dt="2022-08-02T00:08:14.827" v="404" actId="1037"/>
      <pc:docMkLst>
        <pc:docMk/>
      </pc:docMkLst>
      <pc:sldChg chg="addSp modSp mod">
        <pc:chgData name="zhang hui" userId="7090c9456b8cb81b" providerId="LiveId" clId="{62F64228-9980-41C1-88AD-9232BC37B018}" dt="2022-07-28T11:46:42.551" v="69" actId="554"/>
        <pc:sldMkLst>
          <pc:docMk/>
          <pc:sldMk cId="1021492719" sldId="256"/>
        </pc:sldMkLst>
        <pc:spChg chg="add mod">
          <ac:chgData name="zhang hui" userId="7090c9456b8cb81b" providerId="LiveId" clId="{62F64228-9980-41C1-88AD-9232BC37B018}" dt="2022-07-28T11:25:13.631" v="36" actId="404"/>
          <ac:spMkLst>
            <pc:docMk/>
            <pc:sldMk cId="1021492719" sldId="256"/>
            <ac:spMk id="4" creationId="{78A301D7-8DD6-80A6-E1FA-B0CB07F4ED6D}"/>
          </ac:spMkLst>
        </pc:spChg>
        <pc:spChg chg="add mod">
          <ac:chgData name="zhang hui" userId="7090c9456b8cb81b" providerId="LiveId" clId="{62F64228-9980-41C1-88AD-9232BC37B018}" dt="2022-07-28T11:46:42.551" v="69" actId="554"/>
          <ac:spMkLst>
            <pc:docMk/>
            <pc:sldMk cId="1021492719" sldId="256"/>
            <ac:spMk id="6" creationId="{698C252A-7949-6DB6-AEFF-E8C599A75A16}"/>
          </ac:spMkLst>
        </pc:spChg>
        <pc:spChg chg="add mod">
          <ac:chgData name="zhang hui" userId="7090c9456b8cb81b" providerId="LiveId" clId="{62F64228-9980-41C1-88AD-9232BC37B018}" dt="2022-07-28T11:46:42.551" v="69" actId="554"/>
          <ac:spMkLst>
            <pc:docMk/>
            <pc:sldMk cId="1021492719" sldId="256"/>
            <ac:spMk id="11" creationId="{FB4C8344-262B-F0E3-2361-4060CF41B07A}"/>
          </ac:spMkLst>
        </pc:spChg>
        <pc:picChg chg="mod modCrop">
          <ac:chgData name="zhang hui" userId="7090c9456b8cb81b" providerId="LiveId" clId="{62F64228-9980-41C1-88AD-9232BC37B018}" dt="2022-07-28T11:27:07.787" v="61" actId="732"/>
          <ac:picMkLst>
            <pc:docMk/>
            <pc:sldMk cId="1021492719" sldId="256"/>
            <ac:picMk id="7" creationId="{14D058A6-9DE9-2855-C77A-EF5C8636D02F}"/>
          </ac:picMkLst>
        </pc:picChg>
        <pc:picChg chg="add mod modCrop">
          <ac:chgData name="zhang hui" userId="7090c9456b8cb81b" providerId="LiveId" clId="{62F64228-9980-41C1-88AD-9232BC37B018}" dt="2022-07-28T11:26:44.413" v="56" actId="732"/>
          <ac:picMkLst>
            <pc:docMk/>
            <pc:sldMk cId="1021492719" sldId="256"/>
            <ac:picMk id="8" creationId="{0BAF03E6-4B00-4E3E-5BB8-643259278F5F}"/>
          </ac:picMkLst>
        </pc:picChg>
        <pc:picChg chg="add mod modCrop">
          <ac:chgData name="zhang hui" userId="7090c9456b8cb81b" providerId="LiveId" clId="{62F64228-9980-41C1-88AD-9232BC37B018}" dt="2022-07-28T11:27:27.132" v="63" actId="732"/>
          <ac:picMkLst>
            <pc:docMk/>
            <pc:sldMk cId="1021492719" sldId="256"/>
            <ac:picMk id="9" creationId="{1C8A66DE-E666-86DC-D1BA-E61480ADCC9F}"/>
          </ac:picMkLst>
        </pc:picChg>
        <pc:picChg chg="add mod modCrop">
          <ac:chgData name="zhang hui" userId="7090c9456b8cb81b" providerId="LiveId" clId="{62F64228-9980-41C1-88AD-9232BC37B018}" dt="2022-07-28T11:26:04.423" v="51" actId="732"/>
          <ac:picMkLst>
            <pc:docMk/>
            <pc:sldMk cId="1021492719" sldId="256"/>
            <ac:picMk id="10" creationId="{30299E22-C711-CD78-BBE6-127141233233}"/>
          </ac:picMkLst>
        </pc:picChg>
      </pc:sldChg>
      <pc:sldChg chg="addSp delSp modSp mod">
        <pc:chgData name="zhang hui" userId="7090c9456b8cb81b" providerId="LiveId" clId="{62F64228-9980-41C1-88AD-9232BC37B018}" dt="2022-08-02T00:08:14.827" v="404" actId="1037"/>
        <pc:sldMkLst>
          <pc:docMk/>
          <pc:sldMk cId="1757548217" sldId="258"/>
        </pc:sldMkLst>
        <pc:spChg chg="add del mod">
          <ac:chgData name="zhang hui" userId="7090c9456b8cb81b" providerId="LiveId" clId="{62F64228-9980-41C1-88AD-9232BC37B018}" dt="2022-08-01T23:53:42.303" v="134" actId="767"/>
          <ac:spMkLst>
            <pc:docMk/>
            <pc:sldMk cId="1757548217" sldId="258"/>
            <ac:spMk id="2" creationId="{B08E32EB-26D1-3ED9-7A52-E44C55EB31C6}"/>
          </ac:spMkLst>
        </pc:spChg>
        <pc:spChg chg="add mod">
          <ac:chgData name="zhang hui" userId="7090c9456b8cb81b" providerId="LiveId" clId="{62F64228-9980-41C1-88AD-9232BC37B018}" dt="2022-08-02T00:04:23.668" v="198" actId="1076"/>
          <ac:spMkLst>
            <pc:docMk/>
            <pc:sldMk cId="1757548217" sldId="258"/>
            <ac:spMk id="4" creationId="{D650C6D9-8A0D-A197-A5DA-C48220EA7F3E}"/>
          </ac:spMkLst>
        </pc:spChg>
        <pc:spChg chg="add mod">
          <ac:chgData name="zhang hui" userId="7090c9456b8cb81b" providerId="LiveId" clId="{62F64228-9980-41C1-88AD-9232BC37B018}" dt="2022-07-28T11:46:52.168" v="99" actId="1036"/>
          <ac:spMkLst>
            <pc:docMk/>
            <pc:sldMk cId="1757548217" sldId="258"/>
            <ac:spMk id="6" creationId="{F16A299C-E3A3-A915-5736-777E7577DFBC}"/>
          </ac:spMkLst>
        </pc:spChg>
        <pc:spChg chg="add mod">
          <ac:chgData name="zhang hui" userId="7090c9456b8cb81b" providerId="LiveId" clId="{62F64228-9980-41C1-88AD-9232BC37B018}" dt="2022-07-28T11:46:55.207" v="113" actId="1037"/>
          <ac:spMkLst>
            <pc:docMk/>
            <pc:sldMk cId="1757548217" sldId="258"/>
            <ac:spMk id="8" creationId="{4EE77277-E74B-8EC3-8E47-A2C8FE1FE074}"/>
          </ac:spMkLst>
        </pc:spChg>
        <pc:spChg chg="add mod">
          <ac:chgData name="zhang hui" userId="7090c9456b8cb81b" providerId="LiveId" clId="{62F64228-9980-41C1-88AD-9232BC37B018}" dt="2022-07-28T11:47:01.245" v="115" actId="20577"/>
          <ac:spMkLst>
            <pc:docMk/>
            <pc:sldMk cId="1757548217" sldId="258"/>
            <ac:spMk id="9" creationId="{0BF2C4FF-D125-C5BD-79BD-C8F5FE14B4D9}"/>
          </ac:spMkLst>
        </pc:spChg>
        <pc:spChg chg="add mod">
          <ac:chgData name="zhang hui" userId="7090c9456b8cb81b" providerId="LiveId" clId="{62F64228-9980-41C1-88AD-9232BC37B018}" dt="2022-08-02T00:07:52.214" v="397" actId="164"/>
          <ac:spMkLst>
            <pc:docMk/>
            <pc:sldMk cId="1757548217" sldId="258"/>
            <ac:spMk id="17" creationId="{D027A46B-7885-5F73-E179-B74C7C4E5ABC}"/>
          </ac:spMkLst>
        </pc:spChg>
        <pc:spChg chg="add mod">
          <ac:chgData name="zhang hui" userId="7090c9456b8cb81b" providerId="LiveId" clId="{62F64228-9980-41C1-88AD-9232BC37B018}" dt="2022-08-02T00:07:52.214" v="397" actId="164"/>
          <ac:spMkLst>
            <pc:docMk/>
            <pc:sldMk cId="1757548217" sldId="258"/>
            <ac:spMk id="18" creationId="{8B6FC1A8-17BF-ADC4-77B0-16355662094D}"/>
          </ac:spMkLst>
        </pc:spChg>
        <pc:spChg chg="add mod">
          <ac:chgData name="zhang hui" userId="7090c9456b8cb81b" providerId="LiveId" clId="{62F64228-9980-41C1-88AD-9232BC37B018}" dt="2022-08-02T00:07:52.214" v="397" actId="164"/>
          <ac:spMkLst>
            <pc:docMk/>
            <pc:sldMk cId="1757548217" sldId="258"/>
            <ac:spMk id="19" creationId="{B265979C-98C0-E400-8276-C7D2E5F0798A}"/>
          </ac:spMkLst>
        </pc:spChg>
        <pc:spChg chg="add mod">
          <ac:chgData name="zhang hui" userId="7090c9456b8cb81b" providerId="LiveId" clId="{62F64228-9980-41C1-88AD-9232BC37B018}" dt="2022-08-02T00:07:52.214" v="397" actId="164"/>
          <ac:spMkLst>
            <pc:docMk/>
            <pc:sldMk cId="1757548217" sldId="258"/>
            <ac:spMk id="20" creationId="{2D844BA4-E8A3-A976-2979-606FC1B55206}"/>
          </ac:spMkLst>
        </pc:spChg>
        <pc:spChg chg="add mod">
          <ac:chgData name="zhang hui" userId="7090c9456b8cb81b" providerId="LiveId" clId="{62F64228-9980-41C1-88AD-9232BC37B018}" dt="2022-08-02T00:07:48.237" v="396" actId="1076"/>
          <ac:spMkLst>
            <pc:docMk/>
            <pc:sldMk cId="1757548217" sldId="258"/>
            <ac:spMk id="21" creationId="{16218B2C-DCF6-5159-2BE4-833A50E9CE3A}"/>
          </ac:spMkLst>
        </pc:spChg>
        <pc:spChg chg="mod">
          <ac:chgData name="zhang hui" userId="7090c9456b8cb81b" providerId="LiveId" clId="{62F64228-9980-41C1-88AD-9232BC37B018}" dt="2022-08-02T00:07:53.305" v="398"/>
          <ac:spMkLst>
            <pc:docMk/>
            <pc:sldMk cId="1757548217" sldId="258"/>
            <ac:spMk id="24" creationId="{72F7971C-5276-CF97-BFE7-23450866A44F}"/>
          </ac:spMkLst>
        </pc:spChg>
        <pc:spChg chg="mod">
          <ac:chgData name="zhang hui" userId="7090c9456b8cb81b" providerId="LiveId" clId="{62F64228-9980-41C1-88AD-9232BC37B018}" dt="2022-08-02T00:07:53.305" v="398"/>
          <ac:spMkLst>
            <pc:docMk/>
            <pc:sldMk cId="1757548217" sldId="258"/>
            <ac:spMk id="25" creationId="{9903D81A-EE3E-35C3-93C5-890AAF56FEC7}"/>
          </ac:spMkLst>
        </pc:spChg>
        <pc:spChg chg="mod">
          <ac:chgData name="zhang hui" userId="7090c9456b8cb81b" providerId="LiveId" clId="{62F64228-9980-41C1-88AD-9232BC37B018}" dt="2022-08-02T00:07:53.305" v="398"/>
          <ac:spMkLst>
            <pc:docMk/>
            <pc:sldMk cId="1757548217" sldId="258"/>
            <ac:spMk id="26" creationId="{8B516486-08B2-279D-DE08-85A9FAA1BBE5}"/>
          </ac:spMkLst>
        </pc:spChg>
        <pc:spChg chg="mod">
          <ac:chgData name="zhang hui" userId="7090c9456b8cb81b" providerId="LiveId" clId="{62F64228-9980-41C1-88AD-9232BC37B018}" dt="2022-08-02T00:07:53.305" v="398"/>
          <ac:spMkLst>
            <pc:docMk/>
            <pc:sldMk cId="1757548217" sldId="258"/>
            <ac:spMk id="27" creationId="{457F4F4F-CBF3-3333-5880-594354302B44}"/>
          </ac:spMkLst>
        </pc:spChg>
        <pc:grpChg chg="add mod">
          <ac:chgData name="zhang hui" userId="7090c9456b8cb81b" providerId="LiveId" clId="{62F64228-9980-41C1-88AD-9232BC37B018}" dt="2022-08-02T00:08:09.692" v="402" actId="554"/>
          <ac:grpSpMkLst>
            <pc:docMk/>
            <pc:sldMk cId="1757548217" sldId="258"/>
            <ac:grpSpMk id="22" creationId="{BAE8D106-AED5-3849-4689-602AB7571D0F}"/>
          </ac:grpSpMkLst>
        </pc:grpChg>
        <pc:grpChg chg="add mod">
          <ac:chgData name="zhang hui" userId="7090c9456b8cb81b" providerId="LiveId" clId="{62F64228-9980-41C1-88AD-9232BC37B018}" dt="2022-08-02T00:08:14.827" v="404" actId="1037"/>
          <ac:grpSpMkLst>
            <pc:docMk/>
            <pc:sldMk cId="1757548217" sldId="258"/>
            <ac:grpSpMk id="23" creationId="{3E0A79F9-BE47-4A87-714B-E166B2281C3A}"/>
          </ac:grpSpMkLst>
        </pc:grpChg>
        <pc:picChg chg="add del mod modCrop">
          <ac:chgData name="zhang hui" userId="7090c9456b8cb81b" providerId="LiveId" clId="{62F64228-9980-41C1-88AD-9232BC37B018}" dt="2022-08-02T00:07:20.504" v="365" actId="1076"/>
          <ac:picMkLst>
            <pc:docMk/>
            <pc:sldMk cId="1757548217" sldId="258"/>
            <ac:picMk id="3" creationId="{C8A77D74-2AC8-BED1-2B7B-378DA62F2F0A}"/>
          </ac:picMkLst>
        </pc:picChg>
        <pc:picChg chg="mod modCrop">
          <ac:chgData name="zhang hui" userId="7090c9456b8cb81b" providerId="LiveId" clId="{62F64228-9980-41C1-88AD-9232BC37B018}" dt="2022-08-01T23:54:51.228" v="148" actId="732"/>
          <ac:picMkLst>
            <pc:docMk/>
            <pc:sldMk cId="1757548217" sldId="258"/>
            <ac:picMk id="5" creationId="{AE9B7E6B-BF3F-583A-8A80-D82D4AFD105F}"/>
          </ac:picMkLst>
        </pc:picChg>
        <pc:picChg chg="del">
          <ac:chgData name="zhang hui" userId="7090c9456b8cb81b" providerId="LiveId" clId="{62F64228-9980-41C1-88AD-9232BC37B018}" dt="2022-07-28T11:46:20.379" v="64" actId="478"/>
          <ac:picMkLst>
            <pc:docMk/>
            <pc:sldMk cId="1757548217" sldId="258"/>
            <ac:picMk id="7" creationId="{187DE7EC-0C58-398A-9051-9516CA99CD53}"/>
          </ac:picMkLst>
        </pc:picChg>
        <pc:picChg chg="add mod modCrop">
          <ac:chgData name="zhang hui" userId="7090c9456b8cb81b" providerId="LiveId" clId="{62F64228-9980-41C1-88AD-9232BC37B018}" dt="2022-08-01T23:52:51.085" v="126" actId="732"/>
          <ac:picMkLst>
            <pc:docMk/>
            <pc:sldMk cId="1757548217" sldId="258"/>
            <ac:picMk id="7" creationId="{3E5E2FBB-7B12-A841-C61C-8379686E61FE}"/>
          </ac:picMkLst>
        </pc:picChg>
        <pc:picChg chg="add mod modCrop">
          <ac:chgData name="zhang hui" userId="7090c9456b8cb81b" providerId="LiveId" clId="{62F64228-9980-41C1-88AD-9232BC37B018}" dt="2022-08-01T23:52:30.833" v="123" actId="732"/>
          <ac:picMkLst>
            <pc:docMk/>
            <pc:sldMk cId="1757548217" sldId="258"/>
            <ac:picMk id="10" creationId="{D23E3F10-2FB2-255A-ED5D-C4670C591CF4}"/>
          </ac:picMkLst>
        </pc:picChg>
        <pc:picChg chg="add mod modCrop">
          <ac:chgData name="zhang hui" userId="7090c9456b8cb81b" providerId="LiveId" clId="{62F64228-9980-41C1-88AD-9232BC37B018}" dt="2022-08-01T23:52:11.443" v="121" actId="732"/>
          <ac:picMkLst>
            <pc:docMk/>
            <pc:sldMk cId="1757548217" sldId="258"/>
            <ac:picMk id="11" creationId="{AF35A0A4-827A-BD24-1F51-7FA42975E7D4}"/>
          </ac:picMkLst>
        </pc:picChg>
        <pc:picChg chg="add mod modCrop">
          <ac:chgData name="zhang hui" userId="7090c9456b8cb81b" providerId="LiveId" clId="{62F64228-9980-41C1-88AD-9232BC37B018}" dt="2022-08-01T23:54:40.187" v="146" actId="732"/>
          <ac:picMkLst>
            <pc:docMk/>
            <pc:sldMk cId="1757548217" sldId="258"/>
            <ac:picMk id="12" creationId="{91964911-0E12-6EB2-63AC-D0CFF1A44AB4}"/>
          </ac:picMkLst>
        </pc:picChg>
        <pc:picChg chg="add mod modCrop">
          <ac:chgData name="zhang hui" userId="7090c9456b8cb81b" providerId="LiveId" clId="{62F64228-9980-41C1-88AD-9232BC37B018}" dt="2022-08-01T23:54:30.836" v="144" actId="732"/>
          <ac:picMkLst>
            <pc:docMk/>
            <pc:sldMk cId="1757548217" sldId="258"/>
            <ac:picMk id="13" creationId="{722E471C-33C4-AEF9-882F-63516094DA66}"/>
          </ac:picMkLst>
        </pc:picChg>
        <pc:picChg chg="add mod modCrop">
          <ac:chgData name="zhang hui" userId="7090c9456b8cb81b" providerId="LiveId" clId="{62F64228-9980-41C1-88AD-9232BC37B018}" dt="2022-08-01T23:54:18.895" v="142" actId="732"/>
          <ac:picMkLst>
            <pc:docMk/>
            <pc:sldMk cId="1757548217" sldId="258"/>
            <ac:picMk id="14" creationId="{B17C2A28-3A72-63C6-88E6-A645D4ECDFC6}"/>
          </ac:picMkLst>
        </pc:picChg>
        <pc:picChg chg="add del mod modCrop">
          <ac:chgData name="zhang hui" userId="7090c9456b8cb81b" providerId="LiveId" clId="{62F64228-9980-41C1-88AD-9232BC37B018}" dt="2022-08-02T00:06:21.662" v="345" actId="478"/>
          <ac:picMkLst>
            <pc:docMk/>
            <pc:sldMk cId="1757548217" sldId="258"/>
            <ac:picMk id="15" creationId="{3B62B63C-C4A7-AAE2-1EC7-425C4B347AE8}"/>
          </ac:picMkLst>
        </pc:picChg>
        <pc:picChg chg="add del mod modCrop">
          <ac:chgData name="zhang hui" userId="7090c9456b8cb81b" providerId="LiveId" clId="{62F64228-9980-41C1-88AD-9232BC37B018}" dt="2022-08-02T00:07:43.767" v="395" actId="478"/>
          <ac:picMkLst>
            <pc:docMk/>
            <pc:sldMk cId="1757548217" sldId="258"/>
            <ac:picMk id="16" creationId="{4FF8160D-7F4E-E8C1-7775-0C33293DEDC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972113-3940-937E-A4B0-719BF05331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1B4B828-F52B-0FB1-AC1D-510D91A7EE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102834-8449-C6C6-407D-B7082F532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DECF05-9285-DD0A-6501-9986BF6AEB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781101-2E0D-F39B-CD7D-81EC3ED7F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4495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1866CC-EE0C-44B8-9EB0-8996B7BBC9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2CD0B92-CA63-843B-434D-A323893B81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EE71886-76DC-81D4-F144-9709F3CC3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E42632-3232-CCB5-2790-4815F2A2B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890B5A-3233-867E-4876-E045E5E8D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4150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6F5C0D1-E7F1-FF12-B4AA-B07BEAAF27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8AEC426-6AEC-8CD5-B7FF-DA34EDAEBA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4158EF-D2B0-A833-A05A-D2782CDDC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BC3C3C-A0EA-AD5C-FF62-566DFFC79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0528F8-19A3-BD5A-5062-948CC0A5D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8331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F01260-4F5E-F62E-5404-EC09A7B0B9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0297F3-7FB3-AF50-CBE5-941BF801D4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71BB11-24AA-C176-4656-91CB3EC7C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28D4E8-D86B-516D-56F9-FE8541A89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B7A9FE-7E23-E17A-FC48-7B3AD8F32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2632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3414C0-ACFD-34C5-E7AC-BE3195EEC1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882DB-B903-C5F6-A5E5-A5801DE312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3B3080-B3BA-B9EE-F263-9293F2C3F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41CF51-04A9-E840-EC4B-53859AF02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071733-BE4D-7361-0ABB-55CEB0D5A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2587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763732-2066-F32D-79FE-CFD9E9591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6754A2-1F55-E613-3C58-B9CB0B87DD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E08CDC-7905-A702-5CC5-D4FF118B3E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51BB9E0-6034-044B-3EE7-CF5ECB89D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719B9E-9999-6F73-C4DD-EDB6C4DB34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2551FF5-3E37-AC70-37B5-946C85A305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5800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050ED9-DB6B-D176-E2BE-930C9CEA8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96DED2-6833-BEAF-BB4D-CC96BC6431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32A1779-FC9C-5B9D-0A40-20CE375666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E6468FA-8DEC-3CE9-C197-F3FD89FA66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444A8BB-C130-DBB5-A5E5-751C0CB502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4461249-FB4E-D7FD-C0E6-233C61236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A6BB7AD-6BBB-7B7E-C696-2213A764EB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20A80C9-8D2B-CEF0-A818-13FB71F4D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3938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074A08-462A-4A1A-6B64-C7FB210E3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391FDE2-61C5-D449-3F6C-6186FBAFB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7A271AA-6CEB-EF3C-8DBD-1E7AB81E6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0997AB4-2553-0465-A14F-A9FD21565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3473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D923B3F-0491-5E01-97C1-BEDFC7F40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1D24999-D93B-6BEB-BF89-4CED9C4517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9738C7F-3610-7937-65ED-E716F4644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7225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F5FA85-1E83-23EE-6911-36CB7B0A3B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CFBEE21-251D-EA38-E937-D825143787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90FB123-02B7-9AEC-7A7B-E05C104B56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EB28858-C613-DAB1-CC61-D42BAE32F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18A0944-FA1E-3A07-C909-893C56EBC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7703D54-E34F-B3DC-B8CA-13728731D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7864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9D49B1-4F00-785E-E849-1905FA9BCE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2FA9E5C-B1E0-EA0B-D21A-424C5083B7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839F186-C799-F134-5332-2C6AEE7A8D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66D63F2-7CDF-312B-A246-1E8D96CB3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03982B5-979C-1ACC-226A-9AB43C255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4D205A-919A-667A-9439-852CF5441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0369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4F46A56-5126-DD4D-0A38-F6A00BF581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81982CF-C67C-59EE-6DD8-C470AF3EB1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ED8B85-FA0C-F8AD-F228-BD7FDD3B5D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C7E884-E63A-48E3-BB95-2F8A072C7C53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ADB567-78E0-184F-2143-9E28F959CC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DBF477-BABA-0C88-AF26-913B8944CB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B40E58-7392-4804-B1E7-82FC171BB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4960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5574B04-2279-8C5B-E3C3-98237C7853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992" y="1639824"/>
            <a:ext cx="5093208" cy="338785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4D058A6-9DE9-2855-C77A-EF5C8636D02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10" t="54332"/>
          <a:stretch/>
        </p:blipFill>
        <p:spPr>
          <a:xfrm>
            <a:off x="8933792" y="3708400"/>
            <a:ext cx="2326032" cy="184089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8A301D7-8DD6-80A6-E1FA-B0CB07F4ED6D}"/>
              </a:ext>
            </a:extLst>
          </p:cNvPr>
          <p:cNvSpPr txBox="1"/>
          <p:nvPr/>
        </p:nvSpPr>
        <p:spPr>
          <a:xfrm>
            <a:off x="220717" y="372457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98C252A-7949-6DB6-AEFF-E8C599A75A16}"/>
              </a:ext>
            </a:extLst>
          </p:cNvPr>
          <p:cNvSpPr txBox="1"/>
          <p:nvPr/>
        </p:nvSpPr>
        <p:spPr>
          <a:xfrm>
            <a:off x="220716" y="131826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BAF03E6-4B00-4E3E-5BB8-643259278F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10" t="3015" b="50057"/>
          <a:stretch/>
        </p:blipFill>
        <p:spPr>
          <a:xfrm>
            <a:off x="8933792" y="1639823"/>
            <a:ext cx="2326031" cy="189165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C8A66DE-E666-86DC-D1BA-E61480ADCC9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961" r="53438" b="1"/>
          <a:stretch/>
        </p:blipFill>
        <p:spPr>
          <a:xfrm>
            <a:off x="6671060" y="3733800"/>
            <a:ext cx="2136609" cy="181549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30299E22-C711-CD78-BBE6-12714123323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14" r="53438" b="52600"/>
          <a:stretch/>
        </p:blipFill>
        <p:spPr>
          <a:xfrm>
            <a:off x="6671060" y="1639823"/>
            <a:ext cx="2136609" cy="1789177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FB4C8344-262B-F0E3-2361-4060CF41B07A}"/>
              </a:ext>
            </a:extLst>
          </p:cNvPr>
          <p:cNvSpPr txBox="1"/>
          <p:nvPr/>
        </p:nvSpPr>
        <p:spPr>
          <a:xfrm>
            <a:off x="6057954" y="131826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492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8A77D74-2AC8-BED1-2B7B-378DA62F2F0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36" b="84574"/>
          <a:stretch/>
        </p:blipFill>
        <p:spPr>
          <a:xfrm>
            <a:off x="623865" y="1435100"/>
            <a:ext cx="5132383" cy="24976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E9B7E6B-BF3F-583A-8A80-D82D4AFD10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36" b="82607"/>
          <a:stretch/>
        </p:blipFill>
        <p:spPr>
          <a:xfrm>
            <a:off x="6272786" y="1435100"/>
            <a:ext cx="5103260" cy="31538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16A299C-E3A3-A915-5736-777E7577DFBC}"/>
              </a:ext>
            </a:extLst>
          </p:cNvPr>
          <p:cNvSpPr txBox="1"/>
          <p:nvPr/>
        </p:nvSpPr>
        <p:spPr>
          <a:xfrm>
            <a:off x="229183" y="988059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EE77277-E74B-8EC3-8E47-A2C8FE1FE074}"/>
              </a:ext>
            </a:extLst>
          </p:cNvPr>
          <p:cNvSpPr txBox="1"/>
          <p:nvPr/>
        </p:nvSpPr>
        <p:spPr>
          <a:xfrm>
            <a:off x="5761620" y="988059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BF2C4FF-D125-C5BD-79BD-C8F5FE14B4D9}"/>
              </a:ext>
            </a:extLst>
          </p:cNvPr>
          <p:cNvSpPr txBox="1"/>
          <p:nvPr/>
        </p:nvSpPr>
        <p:spPr>
          <a:xfrm>
            <a:off x="220717" y="372457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3E5E2FBB-7B12-A841-C61C-8379686E61F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869" b="62931"/>
          <a:stretch/>
        </p:blipFill>
        <p:spPr>
          <a:xfrm>
            <a:off x="623865" y="1833033"/>
            <a:ext cx="5132383" cy="57361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23E3F10-2FB2-255A-ED5D-C4670C591CF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545" b="42366"/>
          <a:stretch/>
        </p:blipFill>
        <p:spPr>
          <a:xfrm>
            <a:off x="623865" y="2489199"/>
            <a:ext cx="5132383" cy="60325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F35A0A4-827A-BD24-1F51-7FA42975E7D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109"/>
          <a:stretch/>
        </p:blipFill>
        <p:spPr>
          <a:xfrm>
            <a:off x="623865" y="3175000"/>
            <a:ext cx="5132383" cy="1330325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1964911-0E12-6EB2-63AC-D0CFF1A44AB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868" b="62931"/>
          <a:stretch/>
        </p:blipFill>
        <p:spPr>
          <a:xfrm>
            <a:off x="6272786" y="1833032"/>
            <a:ext cx="5103260" cy="57361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22E471C-33C4-AEF9-882F-63516094DA6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545" b="42366"/>
          <a:stretch/>
        </p:blipFill>
        <p:spPr>
          <a:xfrm>
            <a:off x="6272786" y="2489198"/>
            <a:ext cx="5103260" cy="603252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17C2A28-3A72-63C6-88E6-A645D4ECDFC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109"/>
          <a:stretch/>
        </p:blipFill>
        <p:spPr>
          <a:xfrm>
            <a:off x="6272786" y="3175000"/>
            <a:ext cx="5103260" cy="133032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650C6D9-8A0D-A197-A5DA-C48220EA7F3E}"/>
              </a:ext>
            </a:extLst>
          </p:cNvPr>
          <p:cNvSpPr txBox="1"/>
          <p:nvPr/>
        </p:nvSpPr>
        <p:spPr>
          <a:xfrm>
            <a:off x="1926750" y="1053240"/>
            <a:ext cx="27895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hr5: 1- 181,538,259 (GRCh38)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BAE8D106-AED5-3849-4689-602AB7571D0F}"/>
              </a:ext>
            </a:extLst>
          </p:cNvPr>
          <p:cNvGrpSpPr/>
          <p:nvPr/>
        </p:nvGrpSpPr>
        <p:grpSpPr>
          <a:xfrm>
            <a:off x="817559" y="1361017"/>
            <a:ext cx="2164375" cy="1923130"/>
            <a:chOff x="817559" y="1361017"/>
            <a:chExt cx="2164375" cy="1923130"/>
          </a:xfrm>
        </p:grpSpPr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027A46B-7885-5F73-E179-B74C7C4E5ABC}"/>
                </a:ext>
              </a:extLst>
            </p:cNvPr>
            <p:cNvSpPr txBox="1"/>
            <p:nvPr/>
          </p:nvSpPr>
          <p:spPr>
            <a:xfrm>
              <a:off x="817559" y="2304860"/>
              <a:ext cx="10647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moothSiganl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8B6FC1A8-17BF-ADC4-77B0-16355662094D}"/>
                </a:ext>
              </a:extLst>
            </p:cNvPr>
            <p:cNvSpPr txBox="1"/>
            <p:nvPr/>
          </p:nvSpPr>
          <p:spPr>
            <a:xfrm>
              <a:off x="817559" y="1361017"/>
              <a:ext cx="21643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opy Number State (segments)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B265979C-98C0-E400-8276-C7D2E5F0798A}"/>
                </a:ext>
              </a:extLst>
            </p:cNvPr>
            <p:cNvSpPr txBox="1"/>
            <p:nvPr/>
          </p:nvSpPr>
          <p:spPr>
            <a:xfrm>
              <a:off x="817559" y="1767368"/>
              <a:ext cx="14462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Weighted Log2 ratio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2D844BA4-E8A3-A976-2979-606FC1B55206}"/>
                </a:ext>
              </a:extLst>
            </p:cNvPr>
            <p:cNvSpPr txBox="1"/>
            <p:nvPr/>
          </p:nvSpPr>
          <p:spPr>
            <a:xfrm>
              <a:off x="817559" y="3022537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lle differences 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16218B2C-DCF6-5159-2BE4-833A50E9CE3A}"/>
              </a:ext>
            </a:extLst>
          </p:cNvPr>
          <p:cNvSpPr txBox="1"/>
          <p:nvPr/>
        </p:nvSpPr>
        <p:spPr>
          <a:xfrm>
            <a:off x="7429643" y="1053240"/>
            <a:ext cx="27895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hr7: 1- 159,345,973 (GRCh38)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3E0A79F9-BE47-4A87-714B-E166B2281C3A}"/>
              </a:ext>
            </a:extLst>
          </p:cNvPr>
          <p:cNvGrpSpPr/>
          <p:nvPr/>
        </p:nvGrpSpPr>
        <p:grpSpPr>
          <a:xfrm>
            <a:off x="6444111" y="1361017"/>
            <a:ext cx="2164375" cy="1923130"/>
            <a:chOff x="817559" y="1361017"/>
            <a:chExt cx="2164375" cy="1923130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72F7971C-5276-CF97-BFE7-23450866A44F}"/>
                </a:ext>
              </a:extLst>
            </p:cNvPr>
            <p:cNvSpPr txBox="1"/>
            <p:nvPr/>
          </p:nvSpPr>
          <p:spPr>
            <a:xfrm>
              <a:off x="817559" y="2304860"/>
              <a:ext cx="10647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moothSiganl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9903D81A-EE3E-35C3-93C5-890AAF56FEC7}"/>
                </a:ext>
              </a:extLst>
            </p:cNvPr>
            <p:cNvSpPr txBox="1"/>
            <p:nvPr/>
          </p:nvSpPr>
          <p:spPr>
            <a:xfrm>
              <a:off x="817559" y="1361017"/>
              <a:ext cx="21643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opy Number State (segments)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8B516486-08B2-279D-DE08-85A9FAA1BBE5}"/>
                </a:ext>
              </a:extLst>
            </p:cNvPr>
            <p:cNvSpPr txBox="1"/>
            <p:nvPr/>
          </p:nvSpPr>
          <p:spPr>
            <a:xfrm>
              <a:off x="817559" y="1767368"/>
              <a:ext cx="14462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Weighted Log2 ratio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57F4F4F-CBF3-3333-5880-594354302B44}"/>
                </a:ext>
              </a:extLst>
            </p:cNvPr>
            <p:cNvSpPr txBox="1"/>
            <p:nvPr/>
          </p:nvSpPr>
          <p:spPr>
            <a:xfrm>
              <a:off x="817559" y="3022537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lle differences 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57548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48</Words>
  <Application>Microsoft Office PowerPoint</Application>
  <PresentationFormat>宽屏</PresentationFormat>
  <Paragraphs>1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an liu</dc:creator>
  <cp:lastModifiedBy>zhang hui</cp:lastModifiedBy>
  <cp:revision>3</cp:revision>
  <dcterms:created xsi:type="dcterms:W3CDTF">2022-07-27T08:01:51Z</dcterms:created>
  <dcterms:modified xsi:type="dcterms:W3CDTF">2022-08-02T00:08:29Z</dcterms:modified>
</cp:coreProperties>
</file>